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>
        <p:scale>
          <a:sx n="142" d="100"/>
          <a:sy n="142" d="100"/>
        </p:scale>
        <p:origin x="774" y="-55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0205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8033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3128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4859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2697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193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620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9668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584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219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2553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925B0-8B0B-48CD-9003-9FD424972AFD}" type="datetimeFigureOut">
              <a:rPr lang="es-ES" smtClean="0"/>
              <a:t>03/06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CF3B4-7088-426F-A7F2-7D069FBA79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9958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upo 36"/>
          <p:cNvGrpSpPr/>
          <p:nvPr/>
        </p:nvGrpSpPr>
        <p:grpSpPr>
          <a:xfrm>
            <a:off x="119644" y="6904018"/>
            <a:ext cx="2160000" cy="2905663"/>
            <a:chOff x="2379447" y="6904018"/>
            <a:chExt cx="2160000" cy="2905663"/>
          </a:xfrm>
        </p:grpSpPr>
        <p:pic>
          <p:nvPicPr>
            <p:cNvPr id="29" name="Imagen 2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79447" y="7375193"/>
              <a:ext cx="2160000" cy="2160000"/>
            </a:xfrm>
            <a:prstGeom prst="rect">
              <a:avLst/>
            </a:prstGeom>
          </p:spPr>
        </p:pic>
        <p:sp>
          <p:nvSpPr>
            <p:cNvPr id="32" name="CuadroTexto 31"/>
            <p:cNvSpPr txBox="1"/>
            <p:nvPr/>
          </p:nvSpPr>
          <p:spPr>
            <a:xfrm>
              <a:off x="2384153" y="6904018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Invasive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ucin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</a:p>
            <a:p>
              <a:pPr algn="ctr"/>
              <a:r>
                <a:rPr lang="es-ES" sz="1100" u="sng" dirty="0" smtClean="0">
                  <a:latin typeface="Palatino Linotype" panose="02040502050505030304" pitchFamily="18" charset="0"/>
                </a:rPr>
                <a:t>o. c.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2384153" y="9548071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1.16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1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8" name="Grupo 7"/>
          <p:cNvGrpSpPr/>
          <p:nvPr/>
        </p:nvGrpSpPr>
        <p:grpSpPr>
          <a:xfrm>
            <a:off x="4632874" y="749217"/>
            <a:ext cx="2160000" cy="2905663"/>
            <a:chOff x="139710" y="3832854"/>
            <a:chExt cx="2160000" cy="2905663"/>
          </a:xfrm>
        </p:grpSpPr>
        <p:pic>
          <p:nvPicPr>
            <p:cNvPr id="21" name="Imagen 2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710" y="4304224"/>
              <a:ext cx="2160000" cy="2160000"/>
            </a:xfrm>
            <a:prstGeom prst="rect">
              <a:avLst/>
            </a:prstGeom>
          </p:spPr>
        </p:pic>
        <p:sp>
          <p:nvSpPr>
            <p:cNvPr id="22" name="CuadroTexto 21"/>
            <p:cNvSpPr txBox="1"/>
            <p:nvPr/>
          </p:nvSpPr>
          <p:spPr>
            <a:xfrm>
              <a:off x="139710" y="3832854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Ser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o. c.: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grade &amp;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alignant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potential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139710" y="6476907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7.41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3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9" name="Grupo 8"/>
          <p:cNvGrpSpPr/>
          <p:nvPr/>
        </p:nvGrpSpPr>
        <p:grpSpPr>
          <a:xfrm>
            <a:off x="2355081" y="749217"/>
            <a:ext cx="2167148" cy="2905663"/>
            <a:chOff x="2363321" y="3832854"/>
            <a:chExt cx="2167148" cy="2905663"/>
          </a:xfrm>
        </p:grpSpPr>
        <p:pic>
          <p:nvPicPr>
            <p:cNvPr id="20" name="Imagen 1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3321" y="4297754"/>
              <a:ext cx="2160000" cy="2160000"/>
            </a:xfrm>
            <a:prstGeom prst="rect">
              <a:avLst/>
            </a:prstGeom>
          </p:spPr>
        </p:pic>
        <p:sp>
          <p:nvSpPr>
            <p:cNvPr id="23" name="CuadroTexto 22"/>
            <p:cNvSpPr txBox="1"/>
            <p:nvPr/>
          </p:nvSpPr>
          <p:spPr>
            <a:xfrm>
              <a:off x="2387344" y="3832854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Ser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o. c.: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alignant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potential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2387344" y="6476907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2.59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1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11" name="Grupo 10"/>
          <p:cNvGrpSpPr/>
          <p:nvPr/>
        </p:nvGrpSpPr>
        <p:grpSpPr>
          <a:xfrm>
            <a:off x="139710" y="749217"/>
            <a:ext cx="2160000" cy="2905663"/>
            <a:chOff x="4631786" y="6904018"/>
            <a:chExt cx="2160000" cy="2905663"/>
          </a:xfrm>
        </p:grpSpPr>
        <p:pic>
          <p:nvPicPr>
            <p:cNvPr id="28" name="Imagen 2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31786" y="7362615"/>
              <a:ext cx="2160000" cy="2160000"/>
            </a:xfrm>
            <a:prstGeom prst="rect">
              <a:avLst/>
            </a:prstGeom>
          </p:spPr>
        </p:pic>
        <p:sp>
          <p:nvSpPr>
            <p:cNvPr id="33" name="CuadroTexto 32"/>
            <p:cNvSpPr txBox="1"/>
            <p:nvPr/>
          </p:nvSpPr>
          <p:spPr>
            <a:xfrm>
              <a:off x="4631786" y="6904018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alignant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potential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</a:p>
            <a:p>
              <a:pPr algn="ctr"/>
              <a:r>
                <a:rPr lang="es-ES" sz="1100" u="sng" dirty="0" smtClean="0">
                  <a:latin typeface="Palatino Linotype" panose="02040502050505030304" pitchFamily="18" charset="0"/>
                </a:rPr>
                <a:t>o. c.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4631786" y="9548071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1.20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3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347472" y="347472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>
                <a:latin typeface="Palatino Linotype" panose="02040502050505030304" pitchFamily="18" charset="0"/>
              </a:rPr>
              <a:t>Figure S1</a:t>
            </a:r>
            <a:endParaRPr lang="es-ES" b="1" dirty="0">
              <a:latin typeface="Palatino Linotype" panose="02040502050505030304" pitchFamily="18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140514" y="3832854"/>
            <a:ext cx="2160000" cy="2905663"/>
            <a:chOff x="132522" y="749217"/>
            <a:chExt cx="2160000" cy="2905663"/>
          </a:xfrm>
        </p:grpSpPr>
        <p:pic>
          <p:nvPicPr>
            <p:cNvPr id="15" name="Imagen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522" y="1214220"/>
              <a:ext cx="2160000" cy="2160000"/>
            </a:xfrm>
            <a:prstGeom prst="rect">
              <a:avLst/>
            </a:prstGeom>
          </p:spPr>
        </p:pic>
        <p:sp>
          <p:nvSpPr>
            <p:cNvPr id="12" name="CuadroTexto 11"/>
            <p:cNvSpPr txBox="1"/>
            <p:nvPr/>
          </p:nvSpPr>
          <p:spPr>
            <a:xfrm>
              <a:off x="132522" y="3393270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1.13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2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132522" y="749217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>
                  <a:latin typeface="Palatino Linotype" panose="02040502050505030304" pitchFamily="18" charset="0"/>
                </a:rPr>
                <a:t>High grade </a:t>
              </a:r>
              <a:endParaRPr lang="es-ES" sz="1100" u="sng" dirty="0" smtClean="0">
                <a:latin typeface="Palatino Linotype" panose="02040502050505030304" pitchFamily="18" charset="0"/>
              </a:endParaRPr>
            </a:p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ser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>
                  <a:latin typeface="Palatino Linotype" panose="02040502050505030304" pitchFamily="18" charset="0"/>
                </a:rPr>
                <a:t>o. c.</a:t>
              </a:r>
            </a:p>
          </p:txBody>
        </p:sp>
      </p:grpSp>
      <p:grpSp>
        <p:nvGrpSpPr>
          <p:cNvPr id="6" name="Grupo 5"/>
          <p:cNvGrpSpPr/>
          <p:nvPr/>
        </p:nvGrpSpPr>
        <p:grpSpPr>
          <a:xfrm>
            <a:off x="4623404" y="6904018"/>
            <a:ext cx="2162064" cy="2905663"/>
            <a:chOff x="2361217" y="749217"/>
            <a:chExt cx="2162064" cy="2905663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1217" y="1210608"/>
              <a:ext cx="2160000" cy="2160000"/>
            </a:xfrm>
            <a:prstGeom prst="rect">
              <a:avLst/>
            </a:prstGeom>
          </p:spPr>
        </p:pic>
        <p:sp>
          <p:nvSpPr>
            <p:cNvPr id="13" name="CuadroTexto 12"/>
            <p:cNvSpPr txBox="1"/>
            <p:nvPr/>
          </p:nvSpPr>
          <p:spPr>
            <a:xfrm>
              <a:off x="2380156" y="3393270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4.96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1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2380156" y="749217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>
                  <a:latin typeface="Palatino Linotype" panose="02040502050505030304" pitchFamily="18" charset="0"/>
                </a:rPr>
                <a:t> grade </a:t>
              </a:r>
              <a:endParaRPr lang="es-ES" sz="1100" u="sng" dirty="0" smtClean="0">
                <a:latin typeface="Palatino Linotype" panose="02040502050505030304" pitchFamily="18" charset="0"/>
              </a:endParaRPr>
            </a:p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ser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>
                  <a:latin typeface="Palatino Linotype" panose="02040502050505030304" pitchFamily="18" charset="0"/>
                </a:rPr>
                <a:t>o. c.</a:t>
              </a:r>
            </a:p>
          </p:txBody>
        </p:sp>
      </p:grpSp>
      <p:grpSp>
        <p:nvGrpSpPr>
          <p:cNvPr id="7" name="Grupo 6"/>
          <p:cNvGrpSpPr/>
          <p:nvPr/>
        </p:nvGrpSpPr>
        <p:grpSpPr>
          <a:xfrm>
            <a:off x="2396183" y="3832854"/>
            <a:ext cx="2160000" cy="2905663"/>
            <a:chOff x="4625726" y="749217"/>
            <a:chExt cx="2160000" cy="2905663"/>
          </a:xfrm>
        </p:grpSpPr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5726" y="1207514"/>
              <a:ext cx="2160000" cy="2160000"/>
            </a:xfrm>
            <a:prstGeom prst="rect">
              <a:avLst/>
            </a:prstGeom>
          </p:spPr>
        </p:pic>
        <p:sp>
          <p:nvSpPr>
            <p:cNvPr id="14" name="CuadroTexto 13"/>
            <p:cNvSpPr txBox="1"/>
            <p:nvPr/>
          </p:nvSpPr>
          <p:spPr>
            <a:xfrm>
              <a:off x="4627789" y="3393270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1.31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2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4627789" y="749217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>
                  <a:latin typeface="Palatino Linotype" panose="02040502050505030304" pitchFamily="18" charset="0"/>
                </a:rPr>
                <a:t>High &amp; </a:t>
              </a:r>
              <a:r>
                <a:rPr lang="es-ES" sz="1100" u="sng" dirty="0" err="1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>
                  <a:latin typeface="Palatino Linotype" panose="02040502050505030304" pitchFamily="18" charset="0"/>
                </a:rPr>
                <a:t> grade </a:t>
              </a:r>
              <a:endParaRPr lang="es-ES" sz="1100" u="sng" dirty="0" smtClean="0">
                <a:latin typeface="Palatino Linotype" panose="02040502050505030304" pitchFamily="18" charset="0"/>
              </a:endParaRPr>
            </a:p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ser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>
                  <a:latin typeface="Palatino Linotype" panose="02040502050505030304" pitchFamily="18" charset="0"/>
                </a:rPr>
                <a:t>o. c.</a:t>
              </a:r>
            </a:p>
          </p:txBody>
        </p:sp>
      </p:grpSp>
      <p:grpSp>
        <p:nvGrpSpPr>
          <p:cNvPr id="10" name="Grupo 9"/>
          <p:cNvGrpSpPr/>
          <p:nvPr/>
        </p:nvGrpSpPr>
        <p:grpSpPr>
          <a:xfrm>
            <a:off x="4625726" y="3832854"/>
            <a:ext cx="2160000" cy="2905663"/>
            <a:chOff x="4625726" y="3832854"/>
            <a:chExt cx="2160000" cy="2905663"/>
          </a:xfrm>
        </p:grpSpPr>
        <p:pic>
          <p:nvPicPr>
            <p:cNvPr id="19" name="Imagen 1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5726" y="4291451"/>
              <a:ext cx="2160000" cy="2160000"/>
            </a:xfrm>
            <a:prstGeom prst="rect">
              <a:avLst/>
            </a:prstGeom>
          </p:spPr>
        </p:pic>
        <p:sp>
          <p:nvSpPr>
            <p:cNvPr id="24" name="CuadroTexto 23"/>
            <p:cNvSpPr txBox="1"/>
            <p:nvPr/>
          </p:nvSpPr>
          <p:spPr>
            <a:xfrm>
              <a:off x="4634977" y="3832854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Mucin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o. c.: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invasive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&amp;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alignant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potential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4634977" y="6476907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3.39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2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38" name="Grupo 37"/>
          <p:cNvGrpSpPr/>
          <p:nvPr/>
        </p:nvGrpSpPr>
        <p:grpSpPr>
          <a:xfrm>
            <a:off x="2396183" y="6904018"/>
            <a:ext cx="2160000" cy="2905663"/>
            <a:chOff x="132522" y="6904018"/>
            <a:chExt cx="2160000" cy="2905663"/>
          </a:xfrm>
        </p:grpSpPr>
        <p:pic>
          <p:nvPicPr>
            <p:cNvPr id="30" name="Imagen 2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522" y="7375388"/>
              <a:ext cx="2160000" cy="2160000"/>
            </a:xfrm>
            <a:prstGeom prst="rect">
              <a:avLst/>
            </a:prstGeom>
          </p:spPr>
        </p:pic>
        <p:sp>
          <p:nvSpPr>
            <p:cNvPr id="31" name="CuadroTexto 30"/>
            <p:cNvSpPr txBox="1"/>
            <p:nvPr/>
          </p:nvSpPr>
          <p:spPr>
            <a:xfrm>
              <a:off x="136519" y="6904018"/>
              <a:ext cx="214312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u="sng" dirty="0" err="1" smtClean="0">
                  <a:latin typeface="Palatino Linotype" panose="02040502050505030304" pitchFamily="18" charset="0"/>
                </a:rPr>
                <a:t>Low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alignant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potential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</a:t>
              </a:r>
              <a:r>
                <a:rPr lang="es-ES" sz="1100" u="sng" dirty="0" err="1" smtClean="0">
                  <a:latin typeface="Palatino Linotype" panose="02040502050505030304" pitchFamily="18" charset="0"/>
                </a:rPr>
                <a:t>mucinous</a:t>
              </a:r>
              <a:r>
                <a:rPr lang="es-ES" sz="1100" u="sng" dirty="0" smtClean="0">
                  <a:latin typeface="Palatino Linotype" panose="02040502050505030304" pitchFamily="18" charset="0"/>
                </a:rPr>
                <a:t> o. c.</a:t>
              </a:r>
              <a:endParaRPr lang="es-ES" sz="1100" u="sng" dirty="0">
                <a:latin typeface="Palatino Linotype" panose="02040502050505030304" pitchFamily="18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136519" y="9548071"/>
              <a:ext cx="21431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i="1" dirty="0" smtClean="0">
                  <a:latin typeface="Palatino Linotype" panose="02040502050505030304" pitchFamily="18" charset="0"/>
                </a:rPr>
                <a:t>p-</a:t>
              </a:r>
              <a:r>
                <a:rPr lang="es-ES" sz="1100" i="1" dirty="0" err="1" smtClean="0">
                  <a:latin typeface="Palatino Linotype" panose="02040502050505030304" pitchFamily="18" charset="0"/>
                </a:rPr>
                <a:t>value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= 1.37 </a:t>
              </a:r>
              <a:r>
                <a:rPr lang="es-ES" altLang="es-ES" sz="1100" i="1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×</a:t>
              </a:r>
              <a:r>
                <a:rPr lang="es-ES" sz="1100" i="1" dirty="0" smtClean="0">
                  <a:latin typeface="Palatino Linotype" panose="02040502050505030304" pitchFamily="18" charset="0"/>
                </a:rPr>
                <a:t> 10</a:t>
              </a:r>
              <a:r>
                <a:rPr lang="es-ES" sz="1100" i="1" baseline="30000" dirty="0">
                  <a:latin typeface="Palatino Linotype" panose="02040502050505030304" pitchFamily="18" charset="0"/>
                </a:rPr>
                <a:t>−1</a:t>
              </a:r>
              <a:endParaRPr lang="es-ES" sz="1100" i="1" baseline="300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914043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0618914"/>
              </p:ext>
            </p:extLst>
          </p:nvPr>
        </p:nvGraphicFramePr>
        <p:xfrm>
          <a:off x="1521391" y="1413205"/>
          <a:ext cx="3455990" cy="2146300"/>
        </p:xfrm>
        <a:graphic>
          <a:graphicData uri="http://schemas.openxmlformats.org/drawingml/2006/table">
            <a:tbl>
              <a:tblPr firstRow="1" firstCol="1" bandRow="1"/>
              <a:tblGrid>
                <a:gridCol w="1348789">
                  <a:extLst>
                    <a:ext uri="{9D8B030D-6E8A-4147-A177-3AD203B41FA5}">
                      <a16:colId xmlns:a16="http://schemas.microsoft.com/office/drawing/2014/main" val="1739890943"/>
                    </a:ext>
                  </a:extLst>
                </a:gridCol>
                <a:gridCol w="643951">
                  <a:extLst>
                    <a:ext uri="{9D8B030D-6E8A-4147-A177-3AD203B41FA5}">
                      <a16:colId xmlns:a16="http://schemas.microsoft.com/office/drawing/2014/main" val="1094389084"/>
                    </a:ext>
                  </a:extLst>
                </a:gridCol>
                <a:gridCol w="728144">
                  <a:extLst>
                    <a:ext uri="{9D8B030D-6E8A-4147-A177-3AD203B41FA5}">
                      <a16:colId xmlns:a16="http://schemas.microsoft.com/office/drawing/2014/main" val="3955526016"/>
                    </a:ext>
                  </a:extLst>
                </a:gridCol>
                <a:gridCol w="482656">
                  <a:extLst>
                    <a:ext uri="{9D8B030D-6E8A-4147-A177-3AD203B41FA5}">
                      <a16:colId xmlns:a16="http://schemas.microsoft.com/office/drawing/2014/main" val="3435177832"/>
                    </a:ext>
                  </a:extLst>
                </a:gridCol>
                <a:gridCol w="252450">
                  <a:extLst>
                    <a:ext uri="{9D8B030D-6E8A-4147-A177-3AD203B41FA5}">
                      <a16:colId xmlns:a16="http://schemas.microsoft.com/office/drawing/2014/main" val="3705897750"/>
                    </a:ext>
                  </a:extLst>
                </a:gridCol>
              </a:tblGrid>
              <a:tr h="10033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utcome and method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6833395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u="sng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al cancer</a:t>
                      </a:r>
                      <a:endParaRPr lang="es-ES" sz="1000" u="sng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770649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VW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57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1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84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195898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M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7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75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3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0543352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R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0.0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.2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0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7055292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u="sng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  <a:endParaRPr lang="es-ES" sz="1000" u="sng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429521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VW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.06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0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41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2905529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M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.04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80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2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739053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R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5.79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85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2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580773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u="sng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varian cancer</a:t>
                      </a:r>
                      <a:endParaRPr lang="es-ES" sz="1000" u="sng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991651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VW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86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38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64x10</a:t>
                      </a:r>
                      <a:r>
                        <a:rPr lang="en-US" sz="1000" b="1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5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584500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M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29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45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7x10</a:t>
                      </a:r>
                      <a:r>
                        <a:rPr lang="en-US" sz="1000" b="1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9744800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R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9.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2.6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14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420309"/>
                  </a:ext>
                </a:extLst>
              </a:tr>
            </a:tbl>
          </a:graphicData>
        </a:graphic>
      </p:graphicFrame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079713"/>
              </p:ext>
            </p:extLst>
          </p:nvPr>
        </p:nvGraphicFramePr>
        <p:xfrm>
          <a:off x="790031" y="4438862"/>
          <a:ext cx="4918710" cy="2146300"/>
        </p:xfrm>
        <a:graphic>
          <a:graphicData uri="http://schemas.openxmlformats.org/drawingml/2006/table">
            <a:tbl>
              <a:tblPr firstRow="1" firstCol="1" bandRow="1"/>
              <a:tblGrid>
                <a:gridCol w="3114675">
                  <a:extLst>
                    <a:ext uri="{9D8B030D-6E8A-4147-A177-3AD203B41FA5}">
                      <a16:colId xmlns:a16="http://schemas.microsoft.com/office/drawing/2014/main" val="2732022683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2400328570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3275920452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3586186131"/>
                    </a:ext>
                  </a:extLst>
                </a:gridCol>
              </a:tblGrid>
              <a:tr h="10033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varian cancer subtyp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0620025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ear cell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38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8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353585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verall o. c.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34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7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614052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ndometroid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08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9249672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malignant potential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0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0099214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ous o. c.: low malignant potential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59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4619993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ous o. c.: low grade and low malignant potential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41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442324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gh grade serous o. c.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3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663758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gh grade and low grade serous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1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046447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ucinous o. c.: invasive and low malignant potential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39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693682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vasive mucinous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6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7798610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malignant potential mucinous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7x10</a:t>
                      </a:r>
                      <a:r>
                        <a:rPr lang="en-US" sz="10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2966263"/>
                  </a:ext>
                </a:extLst>
              </a:tr>
              <a:tr h="10477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grade serous o. c.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96x10</a:t>
                      </a:r>
                      <a:r>
                        <a:rPr lang="en-US" sz="10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7110290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790032" y="3606769"/>
            <a:ext cx="4918710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upplementary Table S2.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Global 2SMR estimates between endometriosis and ovarian cancer subtypes, using the </a:t>
            </a:r>
            <a:r>
              <a:rPr kumimoji="0" lang="en-US" altLang="es-ES" sz="9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apkota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et al. endometriosis GWAS as exposure. Estimates were calculated with the Inverse Variance Weighted method. </a:t>
            </a:r>
            <a:r>
              <a:rPr lang="en-US" altLang="es-E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Beta (log Odds Ratio), Standard Error (SE) and p-values are indicated. Ovarian 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cancer (o.</a:t>
            </a:r>
            <a:r>
              <a:rPr kumimoji="0" lang="en-US" altLang="es-ES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c.) 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ubtypes are ordered based on significance. 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347472" y="203094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es-ES" b="1" dirty="0" smtClean="0">
                <a:latin typeface="Palatino Linotype" panose="02040502050505030304" pitchFamily="18" charset="0"/>
              </a:rPr>
              <a:t> </a:t>
            </a:r>
            <a:r>
              <a:rPr lang="es-ES" b="1" dirty="0" err="1" smtClean="0">
                <a:latin typeface="Palatino Linotype" panose="02040502050505030304" pitchFamily="18" charset="0"/>
              </a:rPr>
              <a:t>Tables</a:t>
            </a:r>
            <a:endParaRPr lang="es-ES" b="1" dirty="0">
              <a:latin typeface="Palatino Linotype" panose="02040502050505030304" pitchFamily="18" charset="0"/>
            </a:endParaRPr>
          </a:p>
        </p:txBody>
      </p:sp>
      <p:sp>
        <p:nvSpPr>
          <p:cNvPr id="9" name="Rectangle 2"/>
          <p:cNvSpPr>
            <a:spLocks noChangeArrowheads="1"/>
          </p:cNvSpPr>
          <p:nvPr/>
        </p:nvSpPr>
        <p:spPr bwMode="auto">
          <a:xfrm>
            <a:off x="853319" y="572426"/>
            <a:ext cx="4810337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upplementary Table S1.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Global 2SMR estimates between endometriosis and endometrial, breast and</a:t>
            </a:r>
            <a:r>
              <a:rPr kumimoji="0" lang="en-US" altLang="es-ES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ovarian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cancers, using UKBB endometriosis GWAS as exposure. Estimates were calculated using the Inverse Variance Weighted (IVW), Weighted Median (WM), MR-Egger (MRE) methods. </a:t>
            </a:r>
            <a:r>
              <a:rPr lang="en-US" altLang="es-E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Beta (log Odds Ratio), Standard Error (SE) and p-values are indicated. Significant 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associations (p-value&lt;0.05) are highlighted in bold.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2"/>
          <p:cNvSpPr>
            <a:spLocks noChangeArrowheads="1"/>
          </p:cNvSpPr>
          <p:nvPr/>
        </p:nvSpPr>
        <p:spPr bwMode="auto">
          <a:xfrm>
            <a:off x="898404" y="6735730"/>
            <a:ext cx="4810337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upplementary Table S3.</a:t>
            </a: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</a:t>
            </a:r>
            <a:r>
              <a:rPr lang="en-US" altLang="es-E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ummary information on Beta, Standard Error (SE) and p-values of genetic instruments from </a:t>
            </a:r>
            <a:r>
              <a:rPr lang="en-US" altLang="es-ES" sz="9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Sapkota</a:t>
            </a:r>
            <a:r>
              <a:rPr lang="en-US" altLang="es-E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charset="-34"/>
              </a:rPr>
              <a:t> et al. and UKBB exposure datasets in endometrial, breast and ovarian cancer GWASs used as outcome datasets. SNP: Single Nucleotide Polymorphism; SE: Standard Error.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2" name="Tabla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5487269"/>
              </p:ext>
            </p:extLst>
          </p:nvPr>
        </p:nvGraphicFramePr>
        <p:xfrm>
          <a:off x="692134" y="7454497"/>
          <a:ext cx="5222875" cy="2347722"/>
        </p:xfrm>
        <a:graphic>
          <a:graphicData uri="http://schemas.openxmlformats.org/drawingml/2006/table">
            <a:tbl>
              <a:tblPr firstRow="1" firstCol="1" bandRow="1"/>
              <a:tblGrid>
                <a:gridCol w="860425">
                  <a:extLst>
                    <a:ext uri="{9D8B030D-6E8A-4147-A177-3AD203B41FA5}">
                      <a16:colId xmlns:a16="http://schemas.microsoft.com/office/drawing/2014/main" val="3611570821"/>
                    </a:ext>
                  </a:extLst>
                </a:gridCol>
                <a:gridCol w="449580">
                  <a:extLst>
                    <a:ext uri="{9D8B030D-6E8A-4147-A177-3AD203B41FA5}">
                      <a16:colId xmlns:a16="http://schemas.microsoft.com/office/drawing/2014/main" val="2934890188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3670529352"/>
                    </a:ext>
                  </a:extLst>
                </a:gridCol>
                <a:gridCol w="628015">
                  <a:extLst>
                    <a:ext uri="{9D8B030D-6E8A-4147-A177-3AD203B41FA5}">
                      <a16:colId xmlns:a16="http://schemas.microsoft.com/office/drawing/2014/main" val="755857163"/>
                    </a:ext>
                  </a:extLst>
                </a:gridCol>
                <a:gridCol w="402590">
                  <a:extLst>
                    <a:ext uri="{9D8B030D-6E8A-4147-A177-3AD203B41FA5}">
                      <a16:colId xmlns:a16="http://schemas.microsoft.com/office/drawing/2014/main" val="1521513142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49630356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3643905961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1120356803"/>
                    </a:ext>
                  </a:extLst>
                </a:gridCol>
                <a:gridCol w="449580">
                  <a:extLst>
                    <a:ext uri="{9D8B030D-6E8A-4147-A177-3AD203B41FA5}">
                      <a16:colId xmlns:a16="http://schemas.microsoft.com/office/drawing/2014/main" val="4105372638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373366424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NP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al cancer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varian cancer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95238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ta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2179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u="sng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pkota</a:t>
                      </a:r>
                      <a:r>
                        <a:rPr lang="en-US" sz="800" b="0" u="sng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t al.</a:t>
                      </a:r>
                      <a:endParaRPr lang="es-ES" sz="1000" b="0" u="sng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54651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167418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0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4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13892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203737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0740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90306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1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69121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2700667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11219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53737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4465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7157592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1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2799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7448568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3106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01679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76694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76079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3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5883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654632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3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56536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4762326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5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NP absent in the outcome GWAS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72952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u="sng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KBB</a:t>
                      </a:r>
                      <a:endParaRPr lang="es-ES" sz="1000" b="0" u="sng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8713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6176800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6393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999273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0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2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0551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s1103100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3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x10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0.035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  <a:endParaRPr lang="es-E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x10</a:t>
                      </a:r>
                      <a:r>
                        <a:rPr lang="en-US" sz="800" baseline="30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  <a:endParaRPr lang="es-E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7131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9939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93</TotalTime>
  <Words>722</Words>
  <Application>Microsoft Office PowerPoint</Application>
  <PresentationFormat>A4 (210 x 297 mm)</PresentationFormat>
  <Paragraphs>30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rdia New</vt:lpstr>
      <vt:lpstr>Palatino Linotype</vt:lpstr>
      <vt:lpstr>Times New Roman</vt:lpstr>
      <vt:lpstr>Tema de Office</vt:lpstr>
      <vt:lpstr>Presentación de PowerPoint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ueda 2021 Cancers</dc:title>
  <dc:creator>Admin_local</dc:creator>
  <cp:lastModifiedBy>Admin_local</cp:lastModifiedBy>
  <cp:revision>37</cp:revision>
  <dcterms:created xsi:type="dcterms:W3CDTF">2021-01-23T16:10:23Z</dcterms:created>
  <dcterms:modified xsi:type="dcterms:W3CDTF">2021-06-03T11:35:19Z</dcterms:modified>
</cp:coreProperties>
</file>